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320A97-1873-46F1-A088-B57AB84057D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B54397-FEFB-44AE-B470-8D56633167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37C26B-6861-4CC6-84EE-D72401AAB68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E980CB-97E3-4CCA-9BB0-D8730FEF6F2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2B34E8-2844-41FB-A748-01EB346CF7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8BB3C3-0A42-47A8-AEDA-2AB55069F9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A5EEB7-90B2-483A-A12D-17DF0931C96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017EC1-A006-4502-8100-DBB46A5A26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AC2C88-DFD5-4ED3-B13E-D8C5F727E39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04F952-1458-44FE-ADF8-6485565EF8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BB6A73-96DF-4C35-9DE9-21D0E99C79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439718-AE3D-4A91-9ED1-30E73FA4B3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7E94D2-E363-4643-AF75-5656BCADE6A9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jpeg"/><Relationship Id="rId2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24272" t="14105" r="23303" b="15909"/>
          <a:stretch/>
        </p:blipFill>
        <p:spPr>
          <a:xfrm>
            <a:off x="533520" y="76320"/>
            <a:ext cx="7848360" cy="67053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685800" y="457200"/>
            <a:ext cx="609480" cy="366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609480" y="365040"/>
            <a:ext cx="685800" cy="5335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im_(6X11)_rep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1523880" y="1066680"/>
            <a:ext cx="609840" cy="5335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im_(6X11)_rep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200400" y="2514600"/>
            <a:ext cx="685800" cy="5335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im_(43X62)_rep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038480" y="3200400"/>
            <a:ext cx="685800" cy="60948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im_(43X62)_rep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876920" y="3962520"/>
            <a:ext cx="685800" cy="533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im_(43X62)_rep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791320" y="4648320"/>
            <a:ext cx="685800" cy="5331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im_(37X43)_rep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6629400" y="5410080"/>
            <a:ext cx="685800" cy="5335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im_(37X43)_rep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7467480" y="6095880"/>
            <a:ext cx="685800" cy="5335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im_(37X43)_rep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362320" y="1752480"/>
            <a:ext cx="685800" cy="60984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im_(6X11)_rep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533520" y="1066680"/>
            <a:ext cx="838080" cy="56390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371600" y="1752480"/>
            <a:ext cx="838080" cy="4953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286000" y="2514600"/>
            <a:ext cx="838080" cy="4191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3048120" y="3200400"/>
            <a:ext cx="838080" cy="35053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038480" y="3962520"/>
            <a:ext cx="685800" cy="2895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876920" y="4648320"/>
            <a:ext cx="761760" cy="2057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5791320" y="5334120"/>
            <a:ext cx="685800" cy="13716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6553080" y="6095880"/>
            <a:ext cx="838440" cy="6098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" descr=""/>
          <p:cNvPicPr/>
          <p:nvPr/>
        </p:nvPicPr>
        <p:blipFill>
          <a:blip r:embed="rId1"/>
          <a:stretch/>
        </p:blipFill>
        <p:spPr>
          <a:xfrm>
            <a:off x="1290600" y="152280"/>
            <a:ext cx="6562800" cy="6553440"/>
          </a:xfrm>
          <a:prstGeom prst="rect">
            <a:avLst/>
          </a:prstGeom>
          <a:ln w="0">
            <a:noFill/>
          </a:ln>
        </p:spPr>
      </p:pic>
      <p:sp>
        <p:nvSpPr>
          <p:cNvPr id="61" name=""/>
          <p:cNvSpPr/>
          <p:nvPr/>
        </p:nvSpPr>
        <p:spPr>
          <a:xfrm>
            <a:off x="1523880" y="457200"/>
            <a:ext cx="762120" cy="7621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San_rep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2438280" y="1371600"/>
            <a:ext cx="762120" cy="7621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Tei_rep3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276720" y="2209680"/>
            <a:ext cx="761760" cy="7621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Yak_rep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4191120" y="3124080"/>
            <a:ext cx="761760" cy="76212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Mau_rep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5105520" y="3962520"/>
            <a:ext cx="761760" cy="7617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Sec_rep1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019920" y="4876920"/>
            <a:ext cx="761760" cy="7617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Mel_rep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914400" y="1295280"/>
            <a:ext cx="1447920" cy="53341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2362320" y="2209680"/>
            <a:ext cx="838080" cy="44197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3276720" y="3124080"/>
            <a:ext cx="838080" cy="342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4191120" y="3962520"/>
            <a:ext cx="838080" cy="2819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5029200" y="4876920"/>
            <a:ext cx="838080" cy="182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5943600" y="5791320"/>
            <a:ext cx="914400" cy="838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6781680" y="5791320"/>
            <a:ext cx="914400" cy="761760"/>
          </a:xfrm>
          <a:prstGeom prst="rect">
            <a:avLst/>
          </a:prstGeom>
          <a:solidFill>
            <a:srgbClr val="ffffff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900" spc="-1" strike="noStrike">
                <a:solidFill>
                  <a:srgbClr val="000000"/>
                </a:solidFill>
                <a:latin typeface="Arial"/>
              </a:rPr>
              <a:t>Sim_(6X11)_rep2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5-04T15:23:48Z</dcterms:created>
  <dc:creator>fy25</dc:creator>
  <dc:description/>
  <dc:language>en-US</dc:language>
  <cp:lastModifiedBy>Emma.Pettengale</cp:lastModifiedBy>
  <dcterms:modified xsi:type="dcterms:W3CDTF">2008-01-04T14:41:52Z</dcterms:modified>
  <cp:revision>9</cp:revision>
  <dc:subject/>
  <dc:title>Slide 1</dc:title>
</cp:coreProperties>
</file>